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52" y="3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242231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1275408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135492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456276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94532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604512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1425175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06265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64853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439186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95790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76322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E:\argB,nicB,adeA\Picture7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59633" y="3933056"/>
            <a:ext cx="4562496" cy="27150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39552" y="40466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39552" y="350100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668344" y="332656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. Fig 1</a:t>
            </a:r>
            <a:endParaRPr lang="en-GB" dirty="0"/>
          </a:p>
        </p:txBody>
      </p:sp>
      <p:pic>
        <p:nvPicPr>
          <p:cNvPr id="11" name="Picture 2" descr="E:\argB,nicB,adeA\nicB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59632" y="765008"/>
            <a:ext cx="5381397" cy="273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8"/>
          <p:cNvSpPr/>
          <p:nvPr/>
        </p:nvSpPr>
        <p:spPr>
          <a:xfrm>
            <a:off x="5724128" y="5085184"/>
            <a:ext cx="3419872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rticle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title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et of isogenic auxotrophic strains for constructing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ultipl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gen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deletio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utants and parasexual crossings in Aspergillus niger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journal name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rchive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f Microbiology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uthor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names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Jing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iu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Mark Arentshorst, Felix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eelinger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Arthur F.J. Ram*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Jean Paul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uedraogo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ffiliation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olecular Microbiology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nd Biotechnology, Leiden University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ylviusweg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72, 2333 BE Leiden, the Netherlands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corresponding author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.f.j.ram@biology.leidenuniv.nl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47433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77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eit Leid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, A.F.J.</dc:creator>
  <cp:lastModifiedBy>Arthur Ram</cp:lastModifiedBy>
  <cp:revision>6</cp:revision>
  <dcterms:created xsi:type="dcterms:W3CDTF">2016-03-10T13:24:06Z</dcterms:created>
  <dcterms:modified xsi:type="dcterms:W3CDTF">2016-04-27T10:56:29Z</dcterms:modified>
</cp:coreProperties>
</file>